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63"/>
    <p:restoredTop sz="94713"/>
  </p:normalViewPr>
  <p:slideViewPr>
    <p:cSldViewPr snapToGrid="0" snapToObjects="1">
      <p:cViewPr varScale="1">
        <p:scale>
          <a:sx n="68" d="100"/>
          <a:sy n="68" d="100"/>
        </p:scale>
        <p:origin x="155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9F0532-8B7E-CE48-993A-6077FECB715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8C7068-3195-864D-BDB0-7E17389584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045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76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20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032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406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554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665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086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842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123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760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001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681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テキスト ボックス 54"/>
          <p:cNvSpPr txBox="1"/>
          <p:nvPr/>
        </p:nvSpPr>
        <p:spPr>
          <a:xfrm>
            <a:off x="8347200" y="17576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5 Fig.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09600" y="5892800"/>
            <a:ext cx="81110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5 Fig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K27me3 mapped to the genic region, IRRs, or coding regions of putative mRNA or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グループ化 6"/>
          <p:cNvGrpSpPr/>
          <p:nvPr/>
        </p:nvGrpSpPr>
        <p:grpSpPr>
          <a:xfrm>
            <a:off x="1305356" y="708107"/>
            <a:ext cx="5996840" cy="4968415"/>
            <a:chOff x="735878" y="230118"/>
            <a:chExt cx="5996840" cy="4968415"/>
          </a:xfrm>
        </p:grpSpPr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51C5AFD4-66AB-FE46-AC87-28F9C099872C}"/>
                </a:ext>
              </a:extLst>
            </p:cNvPr>
            <p:cNvCxnSpPr>
              <a:cxnSpLocks/>
            </p:cNvCxnSpPr>
            <p:nvPr/>
          </p:nvCxnSpPr>
          <p:spPr>
            <a:xfrm>
              <a:off x="1404802" y="1529109"/>
              <a:ext cx="2316299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角丸四角形 20">
              <a:extLst>
                <a:ext uri="{FF2B5EF4-FFF2-40B4-BE49-F238E27FC236}">
                  <a16:creationId xmlns:a16="http://schemas.microsoft.com/office/drawing/2014/main" id="{73A487C6-7CFB-6F4F-AEAE-D5A60FE634E0}"/>
                </a:ext>
              </a:extLst>
            </p:cNvPr>
            <p:cNvSpPr/>
            <p:nvPr/>
          </p:nvSpPr>
          <p:spPr>
            <a:xfrm>
              <a:off x="2171907" y="1489316"/>
              <a:ext cx="767413" cy="79585"/>
            </a:xfrm>
            <a:prstGeom prst="roundRect">
              <a:avLst/>
            </a:prstGeom>
            <a:solidFill>
              <a:schemeClr val="tx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BD57C54A-2741-0647-BA17-50B3D776204A}"/>
                </a:ext>
              </a:extLst>
            </p:cNvPr>
            <p:cNvSpPr txBox="1"/>
            <p:nvPr/>
          </p:nvSpPr>
          <p:spPr>
            <a:xfrm>
              <a:off x="1784865" y="1604335"/>
              <a:ext cx="1704399" cy="232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Genic region (total)</a:t>
              </a: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BEDE4ECA-1B80-DE45-9D06-3478BD2D9F69}"/>
                </a:ext>
              </a:extLst>
            </p:cNvPr>
            <p:cNvSpPr txBox="1"/>
            <p:nvPr/>
          </p:nvSpPr>
          <p:spPr>
            <a:xfrm>
              <a:off x="4973201" y="1593870"/>
              <a:ext cx="1161015" cy="232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RRs (total)</a:t>
              </a:r>
            </a:p>
          </p:txBody>
        </p: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20BD8A51-B07F-284B-AF12-77409520FC9E}"/>
                </a:ext>
              </a:extLst>
            </p:cNvPr>
            <p:cNvCxnSpPr>
              <a:cxnSpLocks/>
            </p:cNvCxnSpPr>
            <p:nvPr/>
          </p:nvCxnSpPr>
          <p:spPr>
            <a:xfrm>
              <a:off x="4303776" y="1529109"/>
              <a:ext cx="2316299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角丸四角形 34">
              <a:extLst>
                <a:ext uri="{FF2B5EF4-FFF2-40B4-BE49-F238E27FC236}">
                  <a16:creationId xmlns:a16="http://schemas.microsoft.com/office/drawing/2014/main" id="{B88D43B1-D736-8344-BA68-AC072B88168B}"/>
                </a:ext>
              </a:extLst>
            </p:cNvPr>
            <p:cNvSpPr/>
            <p:nvPr/>
          </p:nvSpPr>
          <p:spPr>
            <a:xfrm>
              <a:off x="5070881" y="1489316"/>
              <a:ext cx="767413" cy="79585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5A4AFB75-594D-B74D-B97B-91F9B0A491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84925" y="230118"/>
              <a:ext cx="2858922" cy="1361210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A19AD6FA-8FED-0647-8EB8-8BBD46FB7A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73796" y="230118"/>
              <a:ext cx="2858922" cy="1361210"/>
            </a:xfrm>
            <a:prstGeom prst="rect">
              <a:avLst/>
            </a:prstGeom>
          </p:spPr>
        </p:pic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7E5AE80-77EF-A543-9F16-05E2A0CC5AAB}"/>
                </a:ext>
              </a:extLst>
            </p:cNvPr>
            <p:cNvSpPr txBox="1"/>
            <p:nvPr/>
          </p:nvSpPr>
          <p:spPr>
            <a:xfrm rot="16200000">
              <a:off x="298580" y="738926"/>
              <a:ext cx="1120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H3K27me3 leve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9E877174-3DF9-F447-8917-65811960373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84925" y="1890794"/>
              <a:ext cx="2858922" cy="1361210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92DA2996-AE22-A940-9332-F3AEB37AA99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84925" y="3551469"/>
              <a:ext cx="2858922" cy="1361210"/>
            </a:xfrm>
            <a:prstGeom prst="rect">
              <a:avLst/>
            </a:prstGeom>
          </p:spPr>
        </p:pic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E8809462-E062-3F46-B6A2-77EB93C6155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73796" y="1890794"/>
              <a:ext cx="2858922" cy="1361210"/>
            </a:xfrm>
            <a:prstGeom prst="rect">
              <a:avLst/>
            </a:prstGeom>
          </p:spPr>
        </p:pic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5A3F82FB-559F-E54D-B7F2-FB7CFF2D536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73796" y="3551469"/>
              <a:ext cx="2858922" cy="1361210"/>
            </a:xfrm>
            <a:prstGeom prst="rect">
              <a:avLst/>
            </a:prstGeom>
          </p:spPr>
        </p:pic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id="{230651C6-8BE3-AD40-9440-0E76A5A31D16}"/>
                </a:ext>
              </a:extLst>
            </p:cNvPr>
            <p:cNvGrpSpPr/>
            <p:nvPr/>
          </p:nvGrpSpPr>
          <p:grpSpPr>
            <a:xfrm>
              <a:off x="1409679" y="3152522"/>
              <a:ext cx="2316299" cy="79585"/>
              <a:chOff x="743369" y="4253620"/>
              <a:chExt cx="2552131" cy="105239"/>
            </a:xfrm>
          </p:grpSpPr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id="{84B9CD95-4A73-9148-9F46-AB01A3E2F0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3369" y="4306240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角丸四角形 32">
                <a:extLst>
                  <a:ext uri="{FF2B5EF4-FFF2-40B4-BE49-F238E27FC236}">
                    <a16:creationId xmlns:a16="http://schemas.microsoft.com/office/drawing/2014/main" id="{AD68B566-B74C-024B-A9E1-9822C9438564}"/>
                  </a:ext>
                </a:extLst>
              </p:cNvPr>
              <p:cNvSpPr/>
              <p:nvPr/>
            </p:nvSpPr>
            <p:spPr>
              <a:xfrm>
                <a:off x="1588576" y="4253620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E544D6B2-5264-3545-A9DC-A1460E2A9570}"/>
                </a:ext>
              </a:extLst>
            </p:cNvPr>
            <p:cNvGrpSpPr/>
            <p:nvPr/>
          </p:nvGrpSpPr>
          <p:grpSpPr>
            <a:xfrm>
              <a:off x="1409679" y="4833094"/>
              <a:ext cx="2316299" cy="79585"/>
              <a:chOff x="750627" y="1953105"/>
              <a:chExt cx="2552131" cy="105239"/>
            </a:xfrm>
          </p:grpSpPr>
          <p:cxnSp>
            <p:nvCxnSpPr>
              <p:cNvPr id="43" name="直線コネクタ 42">
                <a:extLst>
                  <a:ext uri="{FF2B5EF4-FFF2-40B4-BE49-F238E27FC236}">
                    <a16:creationId xmlns:a16="http://schemas.microsoft.com/office/drawing/2014/main" id="{B2330E78-8340-BC46-9A52-47848DA689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0627" y="2005725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角丸四角形 43">
                <a:extLst>
                  <a:ext uri="{FF2B5EF4-FFF2-40B4-BE49-F238E27FC236}">
                    <a16:creationId xmlns:a16="http://schemas.microsoft.com/office/drawing/2014/main" id="{F97FF618-6547-5440-BB2E-209DA7E19D6F}"/>
                  </a:ext>
                </a:extLst>
              </p:cNvPr>
              <p:cNvSpPr/>
              <p:nvPr/>
            </p:nvSpPr>
            <p:spPr>
              <a:xfrm>
                <a:off x="1595834" y="1953105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22F2FBF4-305E-954A-8CBD-6B2F42FB2E9D}"/>
                </a:ext>
              </a:extLst>
            </p:cNvPr>
            <p:cNvGrpSpPr/>
            <p:nvPr/>
          </p:nvGrpSpPr>
          <p:grpSpPr>
            <a:xfrm>
              <a:off x="4290176" y="3152522"/>
              <a:ext cx="2316299" cy="79585"/>
              <a:chOff x="743369" y="4253620"/>
              <a:chExt cx="2552131" cy="105239"/>
            </a:xfrm>
          </p:grpSpPr>
          <p:cxnSp>
            <p:nvCxnSpPr>
              <p:cNvPr id="46" name="直線コネクタ 45">
                <a:extLst>
                  <a:ext uri="{FF2B5EF4-FFF2-40B4-BE49-F238E27FC236}">
                    <a16:creationId xmlns:a16="http://schemas.microsoft.com/office/drawing/2014/main" id="{C9B8C31E-B2BC-B34D-B969-B20764CA4A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3369" y="4306240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角丸四角形 46">
                <a:extLst>
                  <a:ext uri="{FF2B5EF4-FFF2-40B4-BE49-F238E27FC236}">
                    <a16:creationId xmlns:a16="http://schemas.microsoft.com/office/drawing/2014/main" id="{7120AA9D-B58D-FA4E-845D-60156DC4CFD4}"/>
                  </a:ext>
                </a:extLst>
              </p:cNvPr>
              <p:cNvSpPr/>
              <p:nvPr/>
            </p:nvSpPr>
            <p:spPr>
              <a:xfrm>
                <a:off x="1588576" y="4253620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3D341F42-BDF1-7240-8965-6902E2129A77}"/>
                </a:ext>
              </a:extLst>
            </p:cNvPr>
            <p:cNvGrpSpPr/>
            <p:nvPr/>
          </p:nvGrpSpPr>
          <p:grpSpPr>
            <a:xfrm>
              <a:off x="4288748" y="4833094"/>
              <a:ext cx="2316299" cy="79585"/>
              <a:chOff x="743369" y="4253620"/>
              <a:chExt cx="2552131" cy="105239"/>
            </a:xfrm>
          </p:grpSpPr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D22F3660-AFF1-FA46-926E-DAC8B0D1C4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3369" y="4306240"/>
                <a:ext cx="25521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角丸四角形 49">
                <a:extLst>
                  <a:ext uri="{FF2B5EF4-FFF2-40B4-BE49-F238E27FC236}">
                    <a16:creationId xmlns:a16="http://schemas.microsoft.com/office/drawing/2014/main" id="{8A8490CE-D1EB-0046-B27F-BAB385ED2550}"/>
                  </a:ext>
                </a:extLst>
              </p:cNvPr>
              <p:cNvSpPr/>
              <p:nvPr/>
            </p:nvSpPr>
            <p:spPr>
              <a:xfrm>
                <a:off x="1588576" y="4253620"/>
                <a:ext cx="845546" cy="105239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A184A28-2C5C-5F40-8FB6-781F509036E9}"/>
                </a:ext>
              </a:extLst>
            </p:cNvPr>
            <p:cNvSpPr txBox="1"/>
            <p:nvPr/>
          </p:nvSpPr>
          <p:spPr>
            <a:xfrm>
              <a:off x="1975870" y="3289166"/>
              <a:ext cx="1704399" cy="232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lincRNAs (total)</a:t>
              </a: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23736E91-2702-C941-9206-240499DFB867}"/>
                </a:ext>
              </a:extLst>
            </p:cNvPr>
            <p:cNvSpPr txBox="1"/>
            <p:nvPr/>
          </p:nvSpPr>
          <p:spPr>
            <a:xfrm>
              <a:off x="1975870" y="4965784"/>
              <a:ext cx="1704399" cy="232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incRNA</a:t>
              </a: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(total)</a:t>
              </a: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71AC262A-F413-DD4D-8D7B-48FC1832BB70}"/>
                </a:ext>
              </a:extLst>
            </p:cNvPr>
            <p:cNvSpPr txBox="1"/>
            <p:nvPr/>
          </p:nvSpPr>
          <p:spPr>
            <a:xfrm>
              <a:off x="4973201" y="3289166"/>
              <a:ext cx="1704399" cy="232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NATs (total)</a:t>
              </a: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98B2F91A-A969-5046-87DB-3A717ECB5FE5}"/>
                </a:ext>
              </a:extLst>
            </p:cNvPr>
            <p:cNvSpPr txBox="1"/>
            <p:nvPr/>
          </p:nvSpPr>
          <p:spPr>
            <a:xfrm>
              <a:off x="4701509" y="4961067"/>
              <a:ext cx="1903539" cy="232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utative mRNA (total)</a:t>
              </a:r>
            </a:p>
          </p:txBody>
        </p:sp>
        <p:sp>
          <p:nvSpPr>
            <p:cNvPr id="56" name="角丸四角形 55">
              <a:extLst>
                <a:ext uri="{FF2B5EF4-FFF2-40B4-BE49-F238E27FC236}">
                  <a16:creationId xmlns:a16="http://schemas.microsoft.com/office/drawing/2014/main" id="{B88D43B1-D736-8344-BA68-AC072B88168B}"/>
                </a:ext>
              </a:extLst>
            </p:cNvPr>
            <p:cNvSpPr/>
            <p:nvPr/>
          </p:nvSpPr>
          <p:spPr>
            <a:xfrm>
              <a:off x="5070083" y="1486939"/>
              <a:ext cx="785634" cy="81575"/>
            </a:xfrm>
            <a:prstGeom prst="roundRect">
              <a:avLst/>
            </a:prstGeom>
            <a:solidFill>
              <a:schemeClr val="tx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27E5AE80-77EF-A543-9F16-05E2A0CC5AAB}"/>
                </a:ext>
              </a:extLst>
            </p:cNvPr>
            <p:cNvSpPr txBox="1"/>
            <p:nvPr/>
          </p:nvSpPr>
          <p:spPr>
            <a:xfrm rot="16200000">
              <a:off x="298579" y="2413692"/>
              <a:ext cx="1120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H3K27me3 leve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27E5AE80-77EF-A543-9F16-05E2A0CC5AAB}"/>
                </a:ext>
              </a:extLst>
            </p:cNvPr>
            <p:cNvSpPr txBox="1"/>
            <p:nvPr/>
          </p:nvSpPr>
          <p:spPr>
            <a:xfrm rot="16200000">
              <a:off x="301404" y="4094924"/>
              <a:ext cx="1120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H3K27me3 leve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4193228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53</TotalTime>
  <Words>56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Yu Gothic</vt:lpstr>
      <vt:lpstr>Arial</vt:lpstr>
      <vt:lpstr>Calibri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moto</dc:creator>
  <cp:lastModifiedBy>Vijayakumar A478</cp:lastModifiedBy>
  <cp:revision>103</cp:revision>
  <cp:lastPrinted>2020-09-24T05:48:32Z</cp:lastPrinted>
  <dcterms:created xsi:type="dcterms:W3CDTF">2019-06-11T01:58:39Z</dcterms:created>
  <dcterms:modified xsi:type="dcterms:W3CDTF">2021-03-24T01:12:57Z</dcterms:modified>
</cp:coreProperties>
</file>